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09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D7D19A-540A-4B75-A07D-2B80BCBD6E21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71549F-B35B-4FD5-9C84-02765852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5836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F3E5FF-C2F8-4588-8145-E067E99C967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7556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247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153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75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239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25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735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452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797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987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628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403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428C4-FC6B-4AB0-B29B-F1460DFB7F07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9C39D-785A-4262-BC70-365EA42ACC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791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://www.genome.jp/kegg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8257542"/>
              </p:ext>
            </p:extLst>
          </p:nvPr>
        </p:nvGraphicFramePr>
        <p:xfrm>
          <a:off x="4341056" y="464229"/>
          <a:ext cx="4760740" cy="233625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0648"/>
                <a:gridCol w="910648"/>
                <a:gridCol w="910648"/>
                <a:gridCol w="910648"/>
                <a:gridCol w="1118148"/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tein</a:t>
                      </a:r>
                    </a:p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ccession #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cus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C number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iofilm:Planktoni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ratio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27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X87004.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HI00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p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.1.1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wn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527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X87573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HI06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b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.2.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wn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527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X87574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HI06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k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7.2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wn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527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X87709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HI08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i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3.1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wn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527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X87856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HI09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ck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.1.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wn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527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X87971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HI11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no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2.1.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wn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527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X88019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HI11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fk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7.1.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wn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527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X88293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HI147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yk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7.1.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wn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pSp>
        <p:nvGrpSpPr>
          <p:cNvPr id="14" name="Group 13"/>
          <p:cNvGrpSpPr/>
          <p:nvPr/>
        </p:nvGrpSpPr>
        <p:grpSpPr>
          <a:xfrm>
            <a:off x="1337748" y="5681207"/>
            <a:ext cx="2011680" cy="748547"/>
            <a:chOff x="1436224" y="5681207"/>
            <a:chExt cx="2011680" cy="748547"/>
          </a:xfrm>
        </p:grpSpPr>
        <p:sp>
          <p:nvSpPr>
            <p:cNvPr id="6" name="TextBox 5"/>
            <p:cNvSpPr txBox="1"/>
            <p:nvPr/>
          </p:nvSpPr>
          <p:spPr>
            <a:xfrm>
              <a:off x="1857404" y="5681207"/>
              <a:ext cx="15905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otein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ownregulated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in biofilm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1691792" y="5738912"/>
              <a:ext cx="228600" cy="152400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1691792" y="6056347"/>
              <a:ext cx="228600" cy="1524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857404" y="6029644"/>
              <a:ext cx="134684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= gene annotated in 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H</a:t>
              </a: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fluenzae</a:t>
              </a:r>
              <a:endParaRPr 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436224" y="5681207"/>
              <a:ext cx="1950203" cy="74854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433" y="464229"/>
            <a:ext cx="3554991" cy="506437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4179900" y="5210534"/>
            <a:ext cx="4837491" cy="1384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3:  (A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The genes encoding proteins involved in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ergy metabolism that were found to be differentially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ed in th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film:planktoni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amples were plotted on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KEGG pathways using the websit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http://www.genome.jp/keg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/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formation for the proteins plotted in the glycolysis pathway that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d differential expression in our study.</a:t>
            </a:r>
          </a:p>
          <a:p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56405" y="6676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350794" y="6676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5695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Office PowerPoint</Application>
  <PresentationFormat>On-screen Show (4:3)</PresentationFormat>
  <Paragraphs>5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borah Post</dc:creator>
  <cp:lastModifiedBy>Deborah Post</cp:lastModifiedBy>
  <cp:revision>1</cp:revision>
  <dcterms:created xsi:type="dcterms:W3CDTF">2014-11-18T00:46:20Z</dcterms:created>
  <dcterms:modified xsi:type="dcterms:W3CDTF">2014-11-18T00:47:02Z</dcterms:modified>
</cp:coreProperties>
</file>